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73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1" r:id="rId17"/>
    <p:sldId id="272" r:id="rId18"/>
    <p:sldId id="274" r:id="rId19"/>
    <p:sldId id="275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75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AA3CAA-E4CC-4A55-86F7-5DF961057501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EC1CFE-A3F2-430D-BAED-876FB047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6724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EC1CFE-A3F2-430D-BAED-876FB047EFD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952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1017F-D4C6-5759-9214-0DD6E5D8D5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8909A1-89FE-F4B2-85B9-487829EC75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668533-836A-3DE5-9608-84B27DD19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CFBCC7-C753-343D-D59C-5337CA070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C187D-0CA6-AF22-D02E-74427E52C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592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4288F-73A0-516C-7757-4C865E574A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E637BC-56E1-34C4-4229-B33F8087AF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2E9E3-609C-81B4-1C81-D10C1739E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160C70-0286-89DC-31BC-202911E53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55B6FD-5C85-A0F1-2EA5-FCDE09D17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741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C6EB63-6AA9-4CB4-1436-42BEB2422A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E949BC-C9BE-664A-A860-7972E17EE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90C0F7-01C8-216D-8162-833A0DC42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A53395-22AC-D9F0-BDE3-CD2CAECE5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95C45F-0D91-796B-E785-9D44775FD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704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7F42B-7282-BED9-CA9F-8B6318206E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E5056F-2F4B-1F53-20B2-5ABD3091F3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414A0-2473-8BAD-C4DE-9455A8943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447521-A734-EC91-46FC-FB832F5E0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314B46-1425-5CB6-3042-FBA991C0F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549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2D291-F70A-CEFE-624F-5A3AE7D297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E512B0-88BC-D243-84DA-C558A20A6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7DCFF2-744B-64C7-7701-91D933E3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773986-7B27-7F9A-D7A7-1A804D147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C24DD-BA7E-F55D-6261-D352B6D35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50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550FFB-5F6D-A927-F1D2-A3E24A4FC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877CEB-C9A2-ED7E-E9B0-B627FC752B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BF71CA-067C-AAD3-8E80-BD49945099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5660DC-1FFB-3ACF-8BDC-E1E9F54AB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5219D-C86E-5784-1DDD-B463F3B37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A78A06-BE17-C0EE-08E7-FC42F7258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20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2D99BA-586F-A447-0D5A-DBC14DE3FB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20B873-2E4E-5137-B44C-2C84DA6DBC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2C82C0-9BE9-2658-1078-02EF5EFE2A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79B10C-D395-B610-BCE3-D516DF7A8F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3F3156-36C6-6234-9EEC-B459673CC4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AA242C-AEEE-3314-CE78-9A7664C3D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5CEE89-E8A5-152D-7B15-157A8180F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C679F9-5448-28FD-8628-9740D9A71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757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3B408B-70D2-D558-A0B1-B919E0344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84B9A5-778D-FBFF-CF69-2ACEC2FD0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97A610-7C21-2669-1C67-C2FD74341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607570-B918-ECE2-4B01-DB71215EF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489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2548C0-72E7-4F53-7698-9164E188B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1497A9-EBD6-1FE0-E3CE-F4852289D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37588F-B1F9-8753-4E41-362A5F996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83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09E9F-28C3-3E0E-3614-D70937D5E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B93E23-381F-8AD1-20C4-406555ACEE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719725-23A5-F015-35F2-87DE609C6D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9FBAD-81E2-8E8A-3F91-B64F8BB29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7098C-0292-A12D-D9D3-EF58DE699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AB41B-C281-1B56-201A-4CAF27DD4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7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BCE8B-796D-654E-8EDB-4A2FD3ED9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3B5F2A-2A7F-94A0-14D7-1251DCD657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D62885-9E41-452C-341D-965DBF6543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2BD4EC-F0DE-CA4B-D03E-42BE624EE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062B8B-4A63-EB23-51B1-264C45D90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A4A741-C3DF-D8AE-8584-5996E1042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881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F3F7C2-7D07-4BBD-B840-D971FCEC19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97FA18-4396-9A15-EA36-FF58BD6591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ADA68-50E9-44BB-C7CC-99E180B2E0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C5C07-759F-4418-A577-D02D69A87F88}" type="datetimeFigureOut">
              <a:rPr lang="en-US" smtClean="0"/>
              <a:t>2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D7440D-ED02-6EDB-0524-0877E63A7E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8F008A-02B9-87D9-3254-9D904EFF9C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CE283-32A5-4986-8819-A7FBEFF20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1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C61F98F-C9CC-DFE2-7BF0-F13527E742E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85" r="4403"/>
          <a:stretch/>
        </p:blipFill>
        <p:spPr bwMode="auto">
          <a:xfrm rot="5400000">
            <a:off x="2777515" y="-1616971"/>
            <a:ext cx="6446469" cy="968041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DF9CFC0-17CE-A684-7690-12808D7CD84B}"/>
              </a:ext>
            </a:extLst>
          </p:cNvPr>
          <p:cNvSpPr txBox="1"/>
          <p:nvPr/>
        </p:nvSpPr>
        <p:spPr>
          <a:xfrm>
            <a:off x="2751914" y="6446469"/>
            <a:ext cx="71350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E82F16D-67C2-720A-3E91-6145C09B02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1045" y="2192973"/>
            <a:ext cx="5539093" cy="1140777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7544563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457B620-C178-C78A-EC6C-3C7D25996C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809332" y="-448097"/>
            <a:ext cx="6263409" cy="7159603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A20607-580F-99CD-8EE5-F3779EBA4D76}"/>
              </a:ext>
            </a:extLst>
          </p:cNvPr>
          <p:cNvSpPr txBox="1"/>
          <p:nvPr/>
        </p:nvSpPr>
        <p:spPr>
          <a:xfrm>
            <a:off x="3287872" y="6360817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SQC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2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11552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C36B3D5-389B-0874-ABD3-C76E25B51C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902987" y="-356556"/>
            <a:ext cx="6344054" cy="705716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B65D6FC-3322-4909-1BE7-F50DF5F89001}"/>
              </a:ext>
            </a:extLst>
          </p:cNvPr>
          <p:cNvSpPr txBox="1"/>
          <p:nvPr/>
        </p:nvSpPr>
        <p:spPr>
          <a:xfrm>
            <a:off x="3232230" y="6338991"/>
            <a:ext cx="68956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MBC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2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28044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6EC6610-8396-0E93-E1AA-97B25238E2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871467" y="-430649"/>
            <a:ext cx="6449065" cy="7310363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E4D53A0-7DC2-10EF-CAAD-D431E874759E}"/>
              </a:ext>
            </a:extLst>
          </p:cNvPr>
          <p:cNvSpPr txBox="1"/>
          <p:nvPr/>
        </p:nvSpPr>
        <p:spPr>
          <a:xfrm>
            <a:off x="3313254" y="6449065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COSY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2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3617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15E3EF-253A-FC95-052C-3C5174A6CE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51"/>
          <a:stretch/>
        </p:blipFill>
        <p:spPr bwMode="auto">
          <a:xfrm rot="5400000">
            <a:off x="3719609" y="-2106312"/>
            <a:ext cx="6091637" cy="1085314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1F4CA33-0A47-9F97-4A29-C4025E9CB0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9986" y="1717415"/>
            <a:ext cx="3017344" cy="1711585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167C870-A15E-FF03-5CA1-A2C5EE403ADB}"/>
              </a:ext>
            </a:extLst>
          </p:cNvPr>
          <p:cNvSpPr txBox="1"/>
          <p:nvPr/>
        </p:nvSpPr>
        <p:spPr>
          <a:xfrm>
            <a:off x="2978658" y="6366079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3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426951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7D162BE-F2EC-F3D4-22F9-1D8DF2128F9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063805" y="-1802165"/>
            <a:ext cx="6502454" cy="10106784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B0D5169-57AB-CC1B-414D-6375A6D1AA43}"/>
              </a:ext>
            </a:extLst>
          </p:cNvPr>
          <p:cNvSpPr txBox="1"/>
          <p:nvPr/>
        </p:nvSpPr>
        <p:spPr>
          <a:xfrm>
            <a:off x="2259957" y="6317788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C NMR spectrum (1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4478095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039473E-A60B-A133-B10E-58F82264011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9"/>
          <a:stretch/>
        </p:blipFill>
        <p:spPr bwMode="auto">
          <a:xfrm rot="5400000">
            <a:off x="3113897" y="-2027160"/>
            <a:ext cx="6348139" cy="1040246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3E53BD8-B98A-12D2-DAD9-7E6AAF95A12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282" y="2078008"/>
            <a:ext cx="2056242" cy="1730063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7A74246-E1BA-62BD-3716-9B4C9B01BBE9}"/>
              </a:ext>
            </a:extLst>
          </p:cNvPr>
          <p:cNvSpPr txBox="1"/>
          <p:nvPr/>
        </p:nvSpPr>
        <p:spPr>
          <a:xfrm>
            <a:off x="3048965" y="6348139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</a:t>
            </a:r>
            <a:r>
              <a:rPr lang="en-SG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4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3098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C9B326B-5EB4-3831-91E7-985CF7F8D27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54" r="4573"/>
          <a:stretch/>
        </p:blipFill>
        <p:spPr bwMode="auto">
          <a:xfrm rot="5400000">
            <a:off x="4543612" y="-1562547"/>
            <a:ext cx="6177280" cy="930237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BE7CE0A-7383-9BEB-9325-F1BE6708B1E6}"/>
              </a:ext>
            </a:extLst>
          </p:cNvPr>
          <p:cNvSpPr txBox="1"/>
          <p:nvPr/>
        </p:nvSpPr>
        <p:spPr>
          <a:xfrm>
            <a:off x="2757669" y="6383966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C NMR spectrum (1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4</a:t>
            </a:r>
            <a:endParaRPr lang="en-US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90795F0-93B7-BAEE-8B87-CFCC03BAA0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000" y="960924"/>
            <a:ext cx="2586135" cy="4673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982545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43DD235-DD59-B5CF-4368-B7E8239B266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285590" y="-1525590"/>
            <a:ext cx="6244004" cy="9568817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B937F13-A5BD-8AA8-77C5-9943F4C58C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0697" y="2515241"/>
            <a:ext cx="3258764" cy="808984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5640255-2F8D-2951-77EB-F82EC06DBBFE}"/>
              </a:ext>
            </a:extLst>
          </p:cNvPr>
          <p:cNvSpPr txBox="1"/>
          <p:nvPr/>
        </p:nvSpPr>
        <p:spPr>
          <a:xfrm>
            <a:off x="2804160" y="624400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5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4D314C1-45C7-A8D6-2F2B-72E3BE27D1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4722" y="355882"/>
            <a:ext cx="1076475" cy="504895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79443B8-50F0-8731-8696-36F58F0138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24357" y="914166"/>
            <a:ext cx="1076475" cy="4490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163486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hiteboard">
            <a:extLst>
              <a:ext uri="{FF2B5EF4-FFF2-40B4-BE49-F238E27FC236}">
                <a16:creationId xmlns:a16="http://schemas.microsoft.com/office/drawing/2014/main" id="{99DC43B3-9E09-F1B0-AF35-40655AE1A3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5376" y="0"/>
            <a:ext cx="8034000" cy="62539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FCD417A-BA82-64C7-736F-E07B8F6B1447}"/>
              </a:ext>
            </a:extLst>
          </p:cNvPr>
          <p:cNvSpPr txBox="1"/>
          <p:nvPr/>
        </p:nvSpPr>
        <p:spPr>
          <a:xfrm>
            <a:off x="2804160" y="6244005"/>
            <a:ext cx="609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ctr"/>
            <a:r>
              <a:rPr lang="en-SG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TLC spot of pure compounds 1, 2 and 5</a:t>
            </a:r>
            <a:endParaRPr lang="en-US" sz="2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46451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C804AB56-19D1-35BA-3E87-1B6A22FD22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0082"/>
            <a:ext cx="12192000" cy="56406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C7FB658-FCA3-5669-DD58-0D2D7B45B6AE}"/>
              </a:ext>
            </a:extLst>
          </p:cNvPr>
          <p:cNvSpPr txBox="1"/>
          <p:nvPr/>
        </p:nvSpPr>
        <p:spPr>
          <a:xfrm>
            <a:off x="2804160" y="6244005"/>
            <a:ext cx="609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ctr"/>
            <a:r>
              <a:rPr lang="en-SG" sz="2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TLC spot of pure compounds 3 </a:t>
            </a:r>
            <a:r>
              <a:rPr lang="en-SG" sz="2800" b="1" baseline="300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and 4</a:t>
            </a:r>
            <a:endParaRPr lang="en-US" sz="2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7175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0497EE5-40D4-712F-C85A-9C962A69884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37" r="3852"/>
          <a:stretch/>
        </p:blipFill>
        <p:spPr bwMode="auto">
          <a:xfrm rot="5400000">
            <a:off x="4597658" y="-1350039"/>
            <a:ext cx="6320503" cy="9020582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017CABC-FF0D-60F8-E2BE-A720784019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2738676" cy="491890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648E9A4-0590-9577-40A7-9AB576A569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07272" y="828050"/>
            <a:ext cx="922923" cy="394965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255BE49-A604-3FDB-B2EC-6149B55E0FE8}"/>
              </a:ext>
            </a:extLst>
          </p:cNvPr>
          <p:cNvSpPr txBox="1"/>
          <p:nvPr/>
        </p:nvSpPr>
        <p:spPr>
          <a:xfrm>
            <a:off x="1962150" y="6446469"/>
            <a:ext cx="79248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Partially expanded </a:t>
            </a:r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5021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62E13D-0C11-31C5-EFA1-DD734EDF72E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166596" y="-1394943"/>
            <a:ext cx="6192189" cy="8982076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CC298D6-9D30-A63C-DEA8-88A9EF18C325}"/>
              </a:ext>
            </a:extLst>
          </p:cNvPr>
          <p:cNvSpPr txBox="1"/>
          <p:nvPr/>
        </p:nvSpPr>
        <p:spPr>
          <a:xfrm>
            <a:off x="2819400" y="619219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C NMR spectrum (1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21919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F4F40F-B92D-87BE-237B-4330E593FF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216270" y="-856207"/>
            <a:ext cx="6145321" cy="8161507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644AD2B-0B7C-32AE-DFA2-050EEF18A9DD}"/>
              </a:ext>
            </a:extLst>
          </p:cNvPr>
          <p:cNvSpPr txBox="1"/>
          <p:nvPr/>
        </p:nvSpPr>
        <p:spPr>
          <a:xfrm>
            <a:off x="2208177" y="6336782"/>
            <a:ext cx="93456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Partially expanded HSQC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3771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888D2B1-4162-83DA-5F79-DB0F5DC75DA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00" b="3421"/>
          <a:stretch/>
        </p:blipFill>
        <p:spPr bwMode="auto">
          <a:xfrm rot="5400000">
            <a:off x="319581" y="-124393"/>
            <a:ext cx="5658156" cy="6074713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7B54C14-E3F2-528C-DE74-811BC3243A3A}"/>
              </a:ext>
            </a:extLst>
          </p:cNvPr>
          <p:cNvSpPr txBox="1"/>
          <p:nvPr/>
        </p:nvSpPr>
        <p:spPr>
          <a:xfrm>
            <a:off x="1995487" y="6264098"/>
            <a:ext cx="96821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Partially expanded HMBC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88CA057-1AB1-4B00-1B9B-75269521C96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0" t="17328" b="12884"/>
          <a:stretch/>
        </p:blipFill>
        <p:spPr bwMode="auto">
          <a:xfrm rot="5400000">
            <a:off x="6463953" y="384589"/>
            <a:ext cx="5284468" cy="543043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6005246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238465-F79F-0DAC-2EEA-E32DA964B9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933596" y="-916909"/>
            <a:ext cx="6324806" cy="815862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0CD8175-3520-74BF-106E-CBD43E079B59}"/>
              </a:ext>
            </a:extLst>
          </p:cNvPr>
          <p:cNvSpPr txBox="1"/>
          <p:nvPr/>
        </p:nvSpPr>
        <p:spPr>
          <a:xfrm>
            <a:off x="2162174" y="6403943"/>
            <a:ext cx="85629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Partially expanded COSY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1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79055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219AAED-7811-F25E-747E-3541217684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1182" y="0"/>
            <a:ext cx="8914618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0A16427-819E-1BB9-66A0-0067E0DD81F2}"/>
              </a:ext>
            </a:extLst>
          </p:cNvPr>
          <p:cNvSpPr txBox="1"/>
          <p:nvPr/>
        </p:nvSpPr>
        <p:spPr>
          <a:xfrm>
            <a:off x="162290" y="3023761"/>
            <a:ext cx="2619010" cy="8104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/>
            <a:r>
              <a:rPr lang="en-SG" sz="28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RESIMS Spectrum of Compound 1</a:t>
            </a:r>
            <a:endParaRPr lang="en-US" sz="2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76434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07CA613-1B7D-E2F6-18F1-859FFCC66DB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167436" y="-1748934"/>
            <a:ext cx="6070450" cy="9978679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DC437BA-2805-D5E8-8094-F3C21E5246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419" y="81760"/>
            <a:ext cx="818555" cy="53086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032BF49-6759-C56B-5436-44D833FB48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59445" y="1866203"/>
            <a:ext cx="1228896" cy="499179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81E76B4-1056-C7F9-3A7E-220F867793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1812" y="1038784"/>
            <a:ext cx="659691" cy="440324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1413DF2-5B92-B1C3-14FA-9815175A336A}"/>
              </a:ext>
            </a:extLst>
          </p:cNvPr>
          <p:cNvSpPr txBox="1"/>
          <p:nvPr/>
        </p:nvSpPr>
        <p:spPr>
          <a:xfrm>
            <a:off x="3602621" y="6384302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marR="0" indent="-864235" algn="just"/>
            <a:r>
              <a:rPr lang="en-SG" sz="18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1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H NMR spectrum (400 MHz, CDCl</a:t>
            </a:r>
            <a:r>
              <a:rPr lang="en-SG" sz="1800" b="1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3</a:t>
            </a:r>
            <a:r>
              <a:rPr lang="en-SG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Vrinda" panose="020B0502040204020203" pitchFamily="34" charset="0"/>
              </a:rPr>
              <a:t>) of Compound 2</a:t>
            </a:r>
            <a:endParaRPr lang="en-US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Vrinda" panose="020B0502040204020203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FA77920-F9EE-055E-BA10-60A2788E263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2217" y="1386727"/>
            <a:ext cx="3224801" cy="1349376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8517996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DA4A930-4922-63FA-80FD-370DF976E5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390769" y="-1851195"/>
            <a:ext cx="6210944" cy="10214557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0807600-0C9D-9A7F-1BE3-A0449D9C57CC}"/>
              </a:ext>
            </a:extLst>
          </p:cNvPr>
          <p:cNvSpPr txBox="1"/>
          <p:nvPr/>
        </p:nvSpPr>
        <p:spPr>
          <a:xfrm>
            <a:off x="3139633" y="6478409"/>
            <a:ext cx="6094070" cy="3795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64235" indent="-864235" algn="just"/>
            <a:r>
              <a:rPr lang="en-SG" sz="28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Vrinda" panose="020B0502040204020203" pitchFamily="34" charset="0"/>
              </a:rPr>
              <a:t>13C NMR spectrum (100 MHz, CDCl3) of Compound 2 </a:t>
            </a:r>
            <a:endParaRPr lang="en-US" sz="2800" b="1" baseline="30000" dirty="0">
              <a:solidFill>
                <a:srgbClr val="000000"/>
              </a:solidFill>
              <a:latin typeface="Times New Roman" panose="02020603050405020304" pitchFamily="18" charset="0"/>
              <a:cs typeface="Vrind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687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218</Words>
  <Application>Microsoft Office PowerPoint</Application>
  <PresentationFormat>Widescreen</PresentationFormat>
  <Paragraphs>20</Paragraphs>
  <Slides>1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ia Ashrafi</dc:creator>
  <cp:lastModifiedBy>Sania Ashrafi</cp:lastModifiedBy>
  <cp:revision>25</cp:revision>
  <dcterms:created xsi:type="dcterms:W3CDTF">2023-01-16T12:47:42Z</dcterms:created>
  <dcterms:modified xsi:type="dcterms:W3CDTF">2023-02-17T06:30:49Z</dcterms:modified>
</cp:coreProperties>
</file>